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0B514-DE64-0937-B020-41F65B026A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643997-8E60-5724-0027-657B7DB686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A2D53E-20C0-3434-16D6-940DB6AEF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C913BA-C36E-174C-635D-0F3D57CAC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39D06B-0FD3-AF47-85D3-705EE399E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156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69D56-DD05-1D15-9A87-A26C18D0E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CBB184-E502-89BD-C0EB-5E0F8B9A75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BA2170-95A8-BBB1-9599-7F59E1B39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351389-C4E4-C454-D4BC-80E5701D8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2B3F8D-7524-F046-A7E2-E16791E9B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279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B672E4-3100-0D89-B952-9B1C9E334C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D71581-1FD8-A025-CFD3-5FFA6946B0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0C2F5A-A35A-5559-AF80-2C94B479A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EDEED-8DE9-904C-7797-9DB41ACDB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44DBA3-5F35-AAC5-1B50-4C21B6338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40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0728E1-1676-41C5-48DF-15796F575E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6FEA7D-4107-F2B1-6B26-0A9FB56D62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529EF0-4E7C-DAD3-2340-57AC1A28C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4E30E4-E2F7-DD62-8A60-CDE2D70D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680049-A055-37CC-391B-FA5E6F9E5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087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6E166-400A-1917-6293-9C916E738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88FCB5-DD48-306E-E182-FE0352EEA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9AB1F7-4E3A-2670-AC8B-E41154803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CAA6D-D630-A3C9-A9D9-15172C106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C5BEB-C5D3-C52A-DDE8-FB3E2162A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54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D807F-9B4A-FFF6-8700-AA6C0AFBB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57B1F-30B4-708B-2BD3-3AFBC19D7B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C4712A-181C-4F29-61B6-282D5E69B6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FAD384-6B35-2D7F-B014-204E7648E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2D8A2E-5214-A7EA-C7BD-EBB8E726B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9F4800-9E78-D0E6-CB47-836FA3270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949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C3A31-2D33-B31E-ED27-2BE3B9D104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51CB7A-F727-9079-A4B4-A505708BFE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A719D2-5D8B-7F8D-2B82-2B7784D633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EFA8B9-F96E-1DD7-A484-8D7D9D98BE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454340A-4CDF-8D9C-0E52-BE08F124E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060EB2-E7D1-E4F2-578D-6C909F458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387D41-6E3B-E5D6-9094-332573B04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622D7C-5B24-9307-B25B-CEFB7B38C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52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109B11-A1F2-ED4B-05B7-CE5713976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20D0B4-0CB4-52DA-1FFF-478E7F5B4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7E89C9-08C0-7988-9777-3909D9BF9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119586-7F26-F238-6F6C-4A816AAA2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39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3AD1DB-5528-913B-113F-A5F3BB491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1F0076-BA3A-0FD8-AB5E-768BB0EAC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FF084-09C4-5EA0-9AC3-B23A28314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923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456082-9819-9557-3D97-5AA259D297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CCB30-2E54-7237-B3F3-6829174B1C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3781E7-6DDB-45B4-07E9-FEA14BFE8C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D438DA-8987-DA2E-6529-24A11760A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D7F7E9-ED92-C860-FAC2-ADE3DAB32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C1F39C-D54A-C852-E025-5F0EF8DC1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3483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89CD9-268E-EC82-DDC3-0714D86B0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F2A35E-418D-7136-1CB7-B4AE38E431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A29162-AB83-285B-B47F-CE4E359769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ADA8C-FCC7-9ED2-CFBB-725632C10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6EF1C9-6A0C-7F9F-85D1-D1F566538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3AB64F-B3F7-CFFF-B4A0-75EB06D4E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825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749F79-3AF5-0E45-6F00-2E49C8931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B4DAC8-4BF9-F09B-324F-7258DDD148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F7EE2D-BE07-5610-9EE1-CE5EEF8B4F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79BAA6-2BC8-44B4-8198-66A085D9687D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04C5B2-6CDB-FA7A-AD56-8DBA784BAC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C7AFF7-7607-1557-5947-F6B0CDBEE8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9FE673-7EB1-49C2-9EDA-91B21A7C5D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3858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FC8747D-D6D5-4C51-118E-57BB7130FD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7396341"/>
              </p:ext>
            </p:extLst>
          </p:nvPr>
        </p:nvGraphicFramePr>
        <p:xfrm>
          <a:off x="0" y="0"/>
          <a:ext cx="12191998" cy="6858002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662798">
                  <a:extLst>
                    <a:ext uri="{9D8B030D-6E8A-4147-A177-3AD203B41FA5}">
                      <a16:colId xmlns:a16="http://schemas.microsoft.com/office/drawing/2014/main" val="2642722973"/>
                    </a:ext>
                  </a:extLst>
                </a:gridCol>
                <a:gridCol w="1550533">
                  <a:extLst>
                    <a:ext uri="{9D8B030D-6E8A-4147-A177-3AD203B41FA5}">
                      <a16:colId xmlns:a16="http://schemas.microsoft.com/office/drawing/2014/main" val="3534179662"/>
                    </a:ext>
                  </a:extLst>
                </a:gridCol>
                <a:gridCol w="1550533">
                  <a:extLst>
                    <a:ext uri="{9D8B030D-6E8A-4147-A177-3AD203B41FA5}">
                      <a16:colId xmlns:a16="http://schemas.microsoft.com/office/drawing/2014/main" val="3552821441"/>
                    </a:ext>
                  </a:extLst>
                </a:gridCol>
                <a:gridCol w="1081767">
                  <a:extLst>
                    <a:ext uri="{9D8B030D-6E8A-4147-A177-3AD203B41FA5}">
                      <a16:colId xmlns:a16="http://schemas.microsoft.com/office/drawing/2014/main" val="2372700274"/>
                    </a:ext>
                  </a:extLst>
                </a:gridCol>
                <a:gridCol w="1081767">
                  <a:extLst>
                    <a:ext uri="{9D8B030D-6E8A-4147-A177-3AD203B41FA5}">
                      <a16:colId xmlns:a16="http://schemas.microsoft.com/office/drawing/2014/main" val="154367752"/>
                    </a:ext>
                  </a:extLst>
                </a:gridCol>
                <a:gridCol w="1550533">
                  <a:extLst>
                    <a:ext uri="{9D8B030D-6E8A-4147-A177-3AD203B41FA5}">
                      <a16:colId xmlns:a16="http://schemas.microsoft.com/office/drawing/2014/main" val="1314189601"/>
                    </a:ext>
                  </a:extLst>
                </a:gridCol>
                <a:gridCol w="1550533">
                  <a:extLst>
                    <a:ext uri="{9D8B030D-6E8A-4147-A177-3AD203B41FA5}">
                      <a16:colId xmlns:a16="http://schemas.microsoft.com/office/drawing/2014/main" val="2324052322"/>
                    </a:ext>
                  </a:extLst>
                </a:gridCol>
                <a:gridCol w="1081767">
                  <a:extLst>
                    <a:ext uri="{9D8B030D-6E8A-4147-A177-3AD203B41FA5}">
                      <a16:colId xmlns:a16="http://schemas.microsoft.com/office/drawing/2014/main" val="363456944"/>
                    </a:ext>
                  </a:extLst>
                </a:gridCol>
                <a:gridCol w="1081767">
                  <a:extLst>
                    <a:ext uri="{9D8B030D-6E8A-4147-A177-3AD203B41FA5}">
                      <a16:colId xmlns:a16="http://schemas.microsoft.com/office/drawing/2014/main" val="2536005180"/>
                    </a:ext>
                  </a:extLst>
                </a:gridCol>
              </a:tblGrid>
              <a:tr h="339575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12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8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nge in prescribing by region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2329977"/>
                  </a:ext>
                </a:extLst>
              </a:tr>
              <a:tr h="33957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les</a:t>
                      </a:r>
                      <a:endParaRPr lang="en-GB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gland</a:t>
                      </a:r>
                      <a:endParaRPr lang="en-GB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7783871"/>
                  </a:ext>
                </a:extLst>
              </a:tr>
              <a:tr h="82036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stant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nge in prescribing by month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fit (R</a:t>
                      </a:r>
                      <a:r>
                        <a:rPr lang="en-GB" sz="1200" i="1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stant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nge in prescribing by month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fit (R</a:t>
                      </a:r>
                      <a:r>
                        <a:rPr lang="en-GB" sz="1200" i="1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68092090"/>
                  </a:ext>
                </a:extLst>
              </a:tr>
              <a:tr h="73833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triptyline 10 mg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.72 (1400.71, 1500.73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4 (6.36, 7.9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7.92 (1142.91, 1212.93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 (3.49, 4.59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45485838"/>
                  </a:ext>
                </a:extLst>
              </a:tr>
              <a:tr h="54353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triptyline 25 mg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7.31 (657.30, 697.3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 (-0.31, 0.3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2.65 (450.70, 474.60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0 (-0.39, -0.0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923837"/>
                  </a:ext>
                </a:extLst>
              </a:tr>
              <a:tr h="54353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itriptyline 50 mg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3.99 (411.04, 436.94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 (0.25, 0.65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1.85 (274.68, 289.03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41 (-0.12, 0.1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79517427"/>
                  </a:ext>
                </a:extLst>
              </a:tr>
              <a:tr h="54353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mipramin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77 (67.19, 74.34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4 (-0.50, -0.39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78 (45.52, 50.04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9 (-0.32, -0.25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58852558"/>
                  </a:ext>
                </a:extLst>
              </a:tr>
              <a:tr h="4892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sulepin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.36 (123.20, 129.52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93 (-0.98, -0.88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.55 (144.36, 150.74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2 (-1.47, -1.37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09301026"/>
                  </a:ext>
                </a:extLst>
              </a:tr>
              <a:tr h="4892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xepin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7 (6.78, 7.57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7 (-0.08, -0.06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1 (5.31, 5.7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 (-0.046, -0.04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52867433"/>
                  </a:ext>
                </a:extLst>
              </a:tr>
              <a:tr h="4892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ipramin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6 (22.85, 24.66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2 (-0.13, -0.1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36 (24.52, 26.2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2 (-0.095, -0.069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7655110"/>
                  </a:ext>
                </a:extLst>
              </a:tr>
              <a:tr h="4892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fepramin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16 (59.37, 62.96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9 (-0.42, -0.36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20 (35.28, 37.1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 (-0.25, -0.22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0930980"/>
                  </a:ext>
                </a:extLst>
              </a:tr>
              <a:tr h="48920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rtriptylin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85 (65.37, 70.34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(0.03, 0.11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16 (80.95, 87.37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 (0.27, 0.37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05679533"/>
                  </a:ext>
                </a:extLst>
              </a:tr>
              <a:tr h="54353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mipramin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5 (9.69, 10.61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1 (-0.12, -0.10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3 (9.79, 10.67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3 (-0.14, -0.13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577121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35496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F02D43C3F12AA46A2B48849DC50DA28" ma:contentTypeVersion="13" ma:contentTypeDescription="Create a new document." ma:contentTypeScope="" ma:versionID="27335c48e2c79fbc82fad4dfdda4aa05">
  <xsd:schema xmlns:xsd="http://www.w3.org/2001/XMLSchema" xmlns:xs="http://www.w3.org/2001/XMLSchema" xmlns:p="http://schemas.microsoft.com/office/2006/metadata/properties" xmlns:ns2="5f0591a7-1bf1-4bd3-b359-b65729fcc3b6" xmlns:ns3="2e755005-555c-499c-8906-f5f9413612d4" targetNamespace="http://schemas.microsoft.com/office/2006/metadata/properties" ma:root="true" ma:fieldsID="0646ec2dee3cdab5f51859753c8268e5" ns2:_="" ns3:_="">
    <xsd:import namespace="5f0591a7-1bf1-4bd3-b359-b65729fcc3b6"/>
    <xsd:import namespace="2e755005-555c-499c-8906-f5f9413612d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f0591a7-1bf1-4bd3-b359-b65729fcc3b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354608c-5633-40c1-be57-7b60b5f02ae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755005-555c-499c-8906-f5f9413612d4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e80265e7-31ee-42ac-8e12-b9e6485b942f}" ma:internalName="TaxCatchAll" ma:showField="CatchAllData" ma:web="2e755005-555c-499c-8906-f5f9413612d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f0591a7-1bf1-4bd3-b359-b65729fcc3b6">
      <Terms xmlns="http://schemas.microsoft.com/office/infopath/2007/PartnerControls"/>
    </lcf76f155ced4ddcb4097134ff3c332f>
    <TaxCatchAll xmlns="2e755005-555c-499c-8906-f5f9413612d4" xsi:nil="true"/>
  </documentManagement>
</p:properties>
</file>

<file path=customXml/itemProps1.xml><?xml version="1.0" encoding="utf-8"?>
<ds:datastoreItem xmlns:ds="http://schemas.openxmlformats.org/officeDocument/2006/customXml" ds:itemID="{51EB072C-3A39-40C8-AA3E-5B535F627671}"/>
</file>

<file path=customXml/itemProps2.xml><?xml version="1.0" encoding="utf-8"?>
<ds:datastoreItem xmlns:ds="http://schemas.openxmlformats.org/officeDocument/2006/customXml" ds:itemID="{AAE33500-AE60-432F-BC32-B745CC2C7C40}"/>
</file>

<file path=customXml/itemProps3.xml><?xml version="1.0" encoding="utf-8"?>
<ds:datastoreItem xmlns:ds="http://schemas.openxmlformats.org/officeDocument/2006/customXml" ds:itemID="{6D303760-5F7D-4A55-87AA-23B5A79A7A8B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72</Words>
  <Application>Microsoft Office PowerPoint</Application>
  <PresentationFormat>Widescreen</PresentationFormat>
  <Paragraphs>10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tthew Ivory</dc:creator>
  <cp:lastModifiedBy>Matthew Ivory</cp:lastModifiedBy>
  <cp:revision>1</cp:revision>
  <dcterms:created xsi:type="dcterms:W3CDTF">2024-09-27T22:54:27Z</dcterms:created>
  <dcterms:modified xsi:type="dcterms:W3CDTF">2024-09-27T22:58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F02D43C3F12AA46A2B48849DC50DA28</vt:lpwstr>
  </property>
</Properties>
</file>